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58" r:id="rId4"/>
    <p:sldId id="257" r:id="rId5"/>
    <p:sldId id="259" r:id="rId6"/>
    <p:sldId id="260" r:id="rId7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2418" y="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68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916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1926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515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120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7396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583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37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6691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604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82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FB8A20-F65F-4FEF-B21C-FD58C3401DB5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0C2B7-2C75-4921-B820-1CD40605DC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006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04664" y="539552"/>
            <a:ext cx="6264696" cy="36009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s </a:t>
            </a:r>
            <a:r>
              <a:rPr lang="en-US" altLang="ja-JP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role of RND-type efflux pumps in multidrug-resistant mutants of </a:t>
            </a:r>
            <a:r>
              <a:rPr lang="en-US" altLang="ja-JP" sz="12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lebsiella</a:t>
            </a:r>
            <a:r>
              <a:rPr lang="en-US" altLang="ja-JP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neumoniae</a:t>
            </a:r>
            <a:r>
              <a:rPr lang="en-US" altLang="ja-JP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ui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ing Ni 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toyasu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nishi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nak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izusaw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yok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Kitagaw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kanori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Kishi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utoshi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atsubar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mofus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suchi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,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eru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Kurod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, 2, 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akan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gaw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, 2, 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  Department of Microbiology, Graduate School of Medicine, Dentistry and Pharmaceutical Sciences, Okayama University, Okayama 700-8530, Japan 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  Department of Microbiology, Faculty of Pharmaceutical Sciences, Okayama University, Okayama 700-8530, Japan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  Department of Microbiology and Biochemistry, Daiichi University of Pharmacy, Fukuoka 815-8511, Japan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  Department of Microbiology, Graduate School of Biomedical and Health Sciences, Hiroshima University, Hiroshima 734-8553, Japan 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*Corresponding author:  wogawa@daiichi-cps.ac.jp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162771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-ogawa\Documents\1研究１\投稿準備中の論文2\Mutantの分離と解析\コア\Revision\画像チェック用\Fig2 acrA（WO)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 t="10902" r="2849" b="10478"/>
          <a:stretch/>
        </p:blipFill>
        <p:spPr bwMode="auto">
          <a:xfrm>
            <a:off x="1242615" y="323528"/>
            <a:ext cx="4444779" cy="2830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w-ogawa\Documents\1研究１\投稿準備中の論文2\Mutantの分離と解析\コア\Revision\画像チェック用\Fig2 eefA（WO)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5" t="13729" b="9638"/>
          <a:stretch/>
        </p:blipFill>
        <p:spPr bwMode="auto">
          <a:xfrm>
            <a:off x="1283608" y="3779912"/>
            <a:ext cx="4453074" cy="27591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188640" y="7028777"/>
            <a:ext cx="65527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Original photos in Figure 2</a:t>
            </a:r>
          </a:p>
          <a:p>
            <a:r>
              <a:rPr kumimoji="1" lang="en-US" altLang="ja-JP" sz="1200" dirty="0" smtClean="0"/>
              <a:t>From left</a:t>
            </a:r>
            <a:r>
              <a:rPr lang="ja-JP" altLang="en-US" sz="1200" dirty="0"/>
              <a:t> </a:t>
            </a:r>
            <a:r>
              <a:rPr lang="en-US" altLang="ja-JP" sz="1200" dirty="0" smtClean="0"/>
              <a:t>lane</a:t>
            </a:r>
            <a:r>
              <a:rPr lang="en-US" altLang="ja-JP" sz="1200" dirty="0"/>
              <a:t>,</a:t>
            </a:r>
            <a:r>
              <a:rPr kumimoji="1" lang="en-US" altLang="ja-JP" sz="1200" dirty="0" smtClean="0"/>
              <a:t> </a:t>
            </a:r>
            <a:r>
              <a:rPr lang="en-US" altLang="ja-JP" sz="1200" dirty="0" smtClean="0"/>
              <a:t>1 size marker, 2 ATCC 10031, 3 EB256-1, 4 EB256-2, 5 Nov1-8, 6 Nov2-2, 7 OX128, 8&amp;9 size marker, 10 ATCC 10031, 11 EB256-1, 12 EB256-2, 13 Nov1-8, 14 Nov2-2, 15 OX128, 16 size marker</a:t>
            </a:r>
          </a:p>
          <a:p>
            <a:endParaRPr kumimoji="1" lang="en-US" altLang="ja-JP" sz="1200" dirty="0"/>
          </a:p>
          <a:p>
            <a:r>
              <a:rPr lang="en-US" altLang="ja-JP" sz="1200" dirty="0" smtClean="0"/>
              <a:t>Reverse transcription reaction was performed in 2-7 and was not performed  in 10-15 as a negative control.</a:t>
            </a:r>
          </a:p>
          <a:p>
            <a:r>
              <a:rPr lang="en-US" altLang="ja-JP" sz="1200" dirty="0" smtClean="0"/>
              <a:t>The data from lanes 2-8 were used in Figure 2.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20688" y="467544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smtClean="0"/>
              <a:t>acrA</a:t>
            </a:r>
            <a:endParaRPr kumimoji="1" lang="ja-JP" altLang="en-US" i="1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20688" y="3786549"/>
            <a:ext cx="609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err="1" smtClean="0"/>
              <a:t>eef</a:t>
            </a:r>
            <a:r>
              <a:rPr kumimoji="1" lang="en-US" altLang="ja-JP" i="1" dirty="0" err="1" smtClean="0"/>
              <a:t>A</a:t>
            </a:r>
            <a:endParaRPr kumimoji="1" lang="ja-JP" altLang="en-US" i="1" dirty="0"/>
          </a:p>
        </p:txBody>
      </p:sp>
    </p:spTree>
    <p:extLst>
      <p:ext uri="{BB962C8B-B14F-4D97-AF65-F5344CB8AC3E}">
        <p14:creationId xmlns:p14="http://schemas.microsoft.com/office/powerpoint/2010/main" val="974812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w-ogawa\Documents\1研究１\投稿準備中の論文2\Mutantの分離と解析\コア\Revision\画像チェック用\Fig2 kexC（WO)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3" t="15297" r="3829" b="8992"/>
          <a:stretch/>
        </p:blipFill>
        <p:spPr bwMode="auto">
          <a:xfrm>
            <a:off x="1345721" y="467544"/>
            <a:ext cx="4339087" cy="2725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w-ogawa\Documents\1研究１\投稿準備中の論文2\Mutantの分離と解析\コア\Revision\画像チェック用\Fig2 kexD（WO)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3" t="6553" r="3829" b="17497"/>
          <a:stretch/>
        </p:blipFill>
        <p:spPr bwMode="auto">
          <a:xfrm>
            <a:off x="1345721" y="3851920"/>
            <a:ext cx="4339087" cy="27345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620688" y="467544"/>
            <a:ext cx="606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 smtClean="0"/>
              <a:t>kexC</a:t>
            </a:r>
            <a:endParaRPr kumimoji="1" lang="ja-JP" altLang="en-US" i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20688" y="3786549"/>
            <a:ext cx="629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err="1" smtClean="0"/>
              <a:t>kexD</a:t>
            </a:r>
            <a:endParaRPr kumimoji="1" lang="ja-JP" altLang="en-US" i="1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8640" y="7028777"/>
            <a:ext cx="65527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Original photos in Figure 2</a:t>
            </a:r>
          </a:p>
          <a:p>
            <a:r>
              <a:rPr kumimoji="1" lang="en-US" altLang="ja-JP" sz="1200" dirty="0" smtClean="0"/>
              <a:t>From left</a:t>
            </a:r>
            <a:r>
              <a:rPr lang="ja-JP" altLang="en-US" sz="1200" dirty="0"/>
              <a:t> </a:t>
            </a:r>
            <a:r>
              <a:rPr lang="en-US" altLang="ja-JP" sz="1200" dirty="0" smtClean="0"/>
              <a:t>lane</a:t>
            </a:r>
            <a:r>
              <a:rPr lang="en-US" altLang="ja-JP" sz="1200" dirty="0"/>
              <a:t>,</a:t>
            </a:r>
            <a:r>
              <a:rPr kumimoji="1" lang="en-US" altLang="ja-JP" sz="1200" dirty="0" smtClean="0"/>
              <a:t> </a:t>
            </a:r>
            <a:r>
              <a:rPr lang="en-US" altLang="ja-JP" sz="1200" dirty="0" smtClean="0"/>
              <a:t>1 size marker, 2 ATCC 10031, 3 EB256-1, 4 EB256-2, 5 Nov1-8, 6 Nov2-2, 7 OX128, 8&amp;9 size marker, 10 ATCC 10031, 11 EB256-1, 12 EB256-2, 13 Nov1-8, 14 Nov2-2, 15 OX128, 16 size marker</a:t>
            </a:r>
          </a:p>
          <a:p>
            <a:endParaRPr kumimoji="1" lang="en-US" altLang="ja-JP" sz="1200" dirty="0"/>
          </a:p>
          <a:p>
            <a:r>
              <a:rPr lang="en-US" altLang="ja-JP" sz="1200" dirty="0" smtClean="0"/>
              <a:t>Reverse transcription reaction was performed in 2-7 and was not performed  in 10-15 as a negative control.</a:t>
            </a:r>
          </a:p>
          <a:p>
            <a:r>
              <a:rPr lang="en-US" altLang="ja-JP" sz="1200" dirty="0" smtClean="0"/>
              <a:t>The data from lanes 2-8 were used in Figure 2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065097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C:\Users\w-ogawa\Documents\1研究１\投稿準備中の論文2\Mutantの分離と解析\コア\Revision\画像チェック用\Fig2 kexE（WO)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076" r="6577" b="15380"/>
          <a:stretch/>
        </p:blipFill>
        <p:spPr bwMode="auto">
          <a:xfrm>
            <a:off x="1124744" y="439947"/>
            <a:ext cx="4499679" cy="2863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w-ogawa\Documents\1研究１\投稿準備中の論文2\Mutantの分離と解析\コア\Revision\画像チェック用\Fig2 oqxA-1（WO)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7" t="3624" r="1" b="20665"/>
          <a:stretch/>
        </p:blipFill>
        <p:spPr bwMode="auto">
          <a:xfrm>
            <a:off x="1261241" y="3851920"/>
            <a:ext cx="4442380" cy="2725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476672" y="467544"/>
            <a:ext cx="598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err="1" smtClean="0"/>
              <a:t>kexE</a:t>
            </a:r>
            <a:endParaRPr kumimoji="1" lang="ja-JP" altLang="en-US" i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76672" y="3786549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 err="1" smtClean="0"/>
              <a:t>oqxA</a:t>
            </a:r>
            <a:endParaRPr kumimoji="1" lang="ja-JP" altLang="en-US" i="1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8640" y="7028777"/>
            <a:ext cx="65527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Original photos in Figure 2</a:t>
            </a:r>
          </a:p>
          <a:p>
            <a:r>
              <a:rPr kumimoji="1" lang="en-US" altLang="ja-JP" sz="1200" dirty="0" smtClean="0"/>
              <a:t>From left</a:t>
            </a:r>
            <a:r>
              <a:rPr lang="ja-JP" altLang="en-US" sz="1200" dirty="0"/>
              <a:t> </a:t>
            </a:r>
            <a:r>
              <a:rPr lang="en-US" altLang="ja-JP" sz="1200" dirty="0" smtClean="0"/>
              <a:t>lane</a:t>
            </a:r>
            <a:r>
              <a:rPr lang="en-US" altLang="ja-JP" sz="1200" dirty="0"/>
              <a:t>,</a:t>
            </a:r>
            <a:r>
              <a:rPr kumimoji="1" lang="en-US" altLang="ja-JP" sz="1200" dirty="0" smtClean="0"/>
              <a:t> </a:t>
            </a:r>
            <a:r>
              <a:rPr lang="en-US" altLang="ja-JP" sz="1200" dirty="0" smtClean="0"/>
              <a:t>1 size marker, 2 ATCC 10031, 3 EB256-1, 4 EB256-2, 5 Nov1-8, 6 Nov2-2, 7 OX128, 8&amp;9 size marker, 10 ATCC 10031, 11 EB256-1, 12 EB256-2, 13 Nov1-8, 14 Nov2-2, 15 OX128, 16 size marker</a:t>
            </a:r>
          </a:p>
          <a:p>
            <a:endParaRPr kumimoji="1" lang="en-US" altLang="ja-JP" sz="1200" dirty="0"/>
          </a:p>
          <a:p>
            <a:r>
              <a:rPr lang="en-US" altLang="ja-JP" sz="1200" dirty="0" smtClean="0"/>
              <a:t>Reverse transcription reaction was performed in 2-7 and was not performed  in 10-15 as a negative control.</a:t>
            </a:r>
          </a:p>
          <a:p>
            <a:r>
              <a:rPr lang="en-US" altLang="ja-JP" sz="1200" dirty="0" smtClean="0"/>
              <a:t>The data from lanes 2-8 were used in Figure 2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869222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C:\Users\w-ogawa\Documents\1研究１\投稿準備中の論文2\Mutantの分離と解析\コア\Revision\画像チェック用\Fig3(a) original by MM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35" b="29790"/>
          <a:stretch/>
        </p:blipFill>
        <p:spPr bwMode="auto">
          <a:xfrm>
            <a:off x="404664" y="683568"/>
            <a:ext cx="5986879" cy="3690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3645024" y="4212522"/>
            <a:ext cx="26441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Fig3(a) original by MM.jpg</a:t>
            </a:r>
            <a:endParaRPr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21739" y="4860032"/>
            <a:ext cx="65527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Scanned X-ray film in Figure 3(a)</a:t>
            </a:r>
          </a:p>
          <a:p>
            <a:r>
              <a:rPr kumimoji="1" lang="en-US" altLang="ja-JP" sz="1200" dirty="0" smtClean="0"/>
              <a:t>From left</a:t>
            </a:r>
            <a:r>
              <a:rPr lang="ja-JP" altLang="en-US" sz="1200" dirty="0"/>
              <a:t> </a:t>
            </a:r>
            <a:r>
              <a:rPr lang="en-US" altLang="ja-JP" sz="1200" dirty="0" smtClean="0"/>
              <a:t>lane:</a:t>
            </a:r>
            <a:r>
              <a:rPr kumimoji="1" lang="en-US" altLang="ja-JP" sz="1200" dirty="0" smtClean="0"/>
              <a:t> “</a:t>
            </a:r>
            <a:r>
              <a:rPr lang="en-US" altLang="ja-JP" sz="1200" dirty="0" smtClean="0"/>
              <a:t>Nov” Nov2-2, “MGH” MGH78578, “ATCC” ATCC10031, “SKY” SKY2, “TG” TG1, “KAM” KAM33, “KAM/</a:t>
            </a:r>
            <a:r>
              <a:rPr lang="en-US" altLang="ja-JP" sz="1200" dirty="0" err="1" smtClean="0"/>
              <a:t>pKEF</a:t>
            </a:r>
            <a:r>
              <a:rPr lang="en-US" altLang="ja-JP" sz="1200" dirty="0" smtClean="0"/>
              <a:t>” KAM33/pKEF28, “KAM/</a:t>
            </a:r>
            <a:r>
              <a:rPr lang="en-US" altLang="ja-JP" sz="1200" dirty="0" err="1" smtClean="0"/>
              <a:t>pKGH</a:t>
            </a:r>
            <a:r>
              <a:rPr lang="en-US" altLang="ja-JP" sz="1200" dirty="0" smtClean="0"/>
              <a:t>” KAM33/pKGH28.</a:t>
            </a:r>
          </a:p>
          <a:p>
            <a:endParaRPr kumimoji="1" lang="en-US" altLang="ja-JP" sz="1200" dirty="0"/>
          </a:p>
          <a:p>
            <a:r>
              <a:rPr lang="en-US" altLang="ja-JP" sz="1200" dirty="0" smtClean="0"/>
              <a:t>The part of the size corresponding to the intact size of RND was used in </a:t>
            </a:r>
            <a:r>
              <a:rPr lang="en-US" altLang="ja-JP" sz="1200" dirty="0"/>
              <a:t>Figure 3(a</a:t>
            </a:r>
            <a:r>
              <a:rPr lang="en-US" altLang="ja-JP" sz="1200" dirty="0" smtClean="0"/>
              <a:t>)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7147468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w-ogawa\Documents\1研究１\投稿準備中の論文2\Mutantの分離と解析\コア\Revision\画像チェック用\Fig3(b)original from MM's protocol 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120" y="0"/>
            <a:ext cx="5270384" cy="7452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1844824" y="7452912"/>
            <a:ext cx="48965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/>
              <a:t>Fig3(b)original from MM's protocol .jpg</a:t>
            </a:r>
            <a:endParaRPr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74948" y="7884368"/>
            <a:ext cx="6552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Scanned lab. notes in Figure 3(b)</a:t>
            </a:r>
          </a:p>
          <a:p>
            <a:r>
              <a:rPr lang="en-US" altLang="ja-JP" sz="1200" dirty="0" smtClean="0"/>
              <a:t>M: MGH78578, A: ATCC10031, N: Nov2-2.  The PCR cycle was titrated, and the results of 31 cycles were used for </a:t>
            </a:r>
            <a:r>
              <a:rPr lang="en-US" altLang="ja-JP" sz="1200" i="1" dirty="0" err="1" smtClean="0"/>
              <a:t>kexE</a:t>
            </a:r>
            <a:r>
              <a:rPr lang="en-US" altLang="ja-JP" sz="1200" dirty="0" smtClean="0"/>
              <a:t> and </a:t>
            </a:r>
            <a:r>
              <a:rPr lang="en-US" altLang="ja-JP" sz="1200" i="1" dirty="0" err="1" smtClean="0"/>
              <a:t>kexF</a:t>
            </a:r>
            <a:r>
              <a:rPr lang="en-US" altLang="ja-JP" sz="1200" dirty="0" smtClean="0"/>
              <a:t>, and those of 27 cycles were used for </a:t>
            </a:r>
            <a:r>
              <a:rPr lang="en-US" altLang="ja-JP" sz="1200" i="1" dirty="0" err="1" smtClean="0"/>
              <a:t>uncB</a:t>
            </a:r>
            <a:r>
              <a:rPr lang="en-US" altLang="ja-JP" sz="1200" dirty="0" smtClean="0"/>
              <a:t> in </a:t>
            </a:r>
            <a:r>
              <a:rPr lang="en-US" altLang="ja-JP" sz="1200" dirty="0"/>
              <a:t>Figure 3(b</a:t>
            </a:r>
            <a:r>
              <a:rPr lang="en-US" altLang="ja-JP" sz="1200" dirty="0" smtClean="0"/>
              <a:t>).   </a:t>
            </a:r>
          </a:p>
          <a:p>
            <a:endParaRPr lang="en-US" altLang="ja-JP" sz="1200" dirty="0"/>
          </a:p>
          <a:p>
            <a:r>
              <a:rPr lang="en-US" altLang="ja-JP" sz="1200" dirty="0" smtClean="0"/>
              <a:t>RT(+) means that the reverse transcription reaction was performed. RT(-) means that the reverse transcription reaction was not used as a negative control. The RT(-) data are not shown in  </a:t>
            </a:r>
            <a:r>
              <a:rPr lang="en-US" altLang="ja-JP" sz="1200" dirty="0"/>
              <a:t>Figure 3(b</a:t>
            </a:r>
            <a:r>
              <a:rPr lang="en-US" altLang="ja-JP" sz="1200" dirty="0" smtClean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4144107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578</Words>
  <Application>Microsoft Office PowerPoint</Application>
  <PresentationFormat>画面に合わせる (4:3)</PresentationFormat>
  <Paragraphs>45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ＭＳ Ｐゴシック</vt:lpstr>
      <vt:lpstr>ＭＳ 明朝</vt:lpstr>
      <vt:lpstr>Arial</vt:lpstr>
      <vt:lpstr>Calibri</vt:lpstr>
      <vt:lpstr>Century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第一薬科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O</dc:creator>
  <cp:lastModifiedBy>小川 和加野</cp:lastModifiedBy>
  <cp:revision>10</cp:revision>
  <dcterms:created xsi:type="dcterms:W3CDTF">2020-03-30T08:51:20Z</dcterms:created>
  <dcterms:modified xsi:type="dcterms:W3CDTF">2020-04-20T00:45:28Z</dcterms:modified>
</cp:coreProperties>
</file>